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8" d="100"/>
          <a:sy n="58" d="100"/>
        </p:scale>
        <p:origin x="-1782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6/03/2015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6/03/2015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6/03/2015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6/03/2015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6/03/2015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6/03/2015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6/03/2015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6/03/2015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6/03/2015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6/03/2015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6/03/2015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09A6D-C09C-4548-B29A-6CF363A7E532}" type="datetimeFigureOut">
              <a:rPr lang="fr-FR" smtClean="0"/>
              <a:t>16/03/2015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0" y="8172400"/>
            <a:ext cx="685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Receiver-operator characteristic of blood SCD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es.</a:t>
            </a: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C analysis to discriminate between ALS patients and controls, based on 16:1/16:0 ratio in serum (B) and blood cell (B) and on 18:1/18:0 ratio in serum (C) and blood cell (D). P-values are also indicated, and test the null hypothesis that the AUC equals 0.50 (n=48).</a:t>
            </a:r>
          </a:p>
        </p:txBody>
      </p:sp>
      <p:pic>
        <p:nvPicPr>
          <p:cNvPr id="1026" name="Picture 2" descr="E:\Publications\Paper - FA Human\04-PlosOne\Figures\Supp Fig 1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1416" y="202534"/>
            <a:ext cx="6335167" cy="6090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4376303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69</Words>
  <Application>Microsoft Office PowerPoint</Application>
  <PresentationFormat>Affichage à l'écran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ex</dc:creator>
  <cp:lastModifiedBy>Alex</cp:lastModifiedBy>
  <cp:revision>4</cp:revision>
  <dcterms:created xsi:type="dcterms:W3CDTF">2015-02-25T15:48:33Z</dcterms:created>
  <dcterms:modified xsi:type="dcterms:W3CDTF">2015-03-16T15:48:37Z</dcterms:modified>
</cp:coreProperties>
</file>